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1536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1A5C51-1153-4369-8F20-2F3ED351663D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DFA555-EECB-4F5E-BA0A-7A343F642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7413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DFA555-EECB-4F5E-BA0A-7A343F642B0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8566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1975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I-HEK293T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AFCE0EF8-AE65-3539-679D-F50A0925777B}"/>
              </a:ext>
            </a:extLst>
          </p:cNvPr>
          <p:cNvSpPr txBox="1"/>
          <p:nvPr/>
        </p:nvSpPr>
        <p:spPr>
          <a:xfrm>
            <a:off x="3072404" y="4469108"/>
            <a:ext cx="11945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IP: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C6014FE-CF7F-27F3-5E39-68E3D644EDF2}"/>
              </a:ext>
            </a:extLst>
          </p:cNvPr>
          <p:cNvSpPr txBox="1"/>
          <p:nvPr/>
        </p:nvSpPr>
        <p:spPr>
          <a:xfrm>
            <a:off x="3230664" y="6188214"/>
            <a:ext cx="1512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WCL: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3A62D75-A727-A415-0FE0-9840C874810B}"/>
              </a:ext>
            </a:extLst>
          </p:cNvPr>
          <p:cNvSpPr txBox="1"/>
          <p:nvPr/>
        </p:nvSpPr>
        <p:spPr>
          <a:xfrm>
            <a:off x="247253" y="325188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53D6376-FC24-9EC0-14CD-51FE9CE7B563}"/>
              </a:ext>
            </a:extLst>
          </p:cNvPr>
          <p:cNvSpPr txBox="1"/>
          <p:nvPr/>
        </p:nvSpPr>
        <p:spPr>
          <a:xfrm>
            <a:off x="3375435" y="3159549"/>
            <a:ext cx="955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IP: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e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ly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C07C5B2-7A2F-B0E1-74BB-DD96F66F1A21}"/>
              </a:ext>
            </a:extLst>
          </p:cNvPr>
          <p:cNvSpPr txBox="1"/>
          <p:nvPr/>
        </p:nvSpPr>
        <p:spPr>
          <a:xfrm rot="19293923">
            <a:off x="686331" y="2728410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46864F3-C14A-A356-BDB8-6F2328351009}"/>
              </a:ext>
            </a:extLst>
          </p:cNvPr>
          <p:cNvSpPr txBox="1"/>
          <p:nvPr/>
        </p:nvSpPr>
        <p:spPr>
          <a:xfrm rot="19438225">
            <a:off x="2365283" y="2414417"/>
            <a:ext cx="149475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Ricolinost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076FED6-E196-1F46-3A9C-B1CB701383D3}"/>
              </a:ext>
            </a:extLst>
          </p:cNvPr>
          <p:cNvSpPr txBox="1"/>
          <p:nvPr/>
        </p:nvSpPr>
        <p:spPr>
          <a:xfrm rot="19438225">
            <a:off x="2007416" y="2170501"/>
            <a:ext cx="23653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MK-2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2A783FA-50C3-B45F-6F73-F9A815A9E7D0}"/>
              </a:ext>
            </a:extLst>
          </p:cNvPr>
          <p:cNvSpPr txBox="1"/>
          <p:nvPr/>
        </p:nvSpPr>
        <p:spPr>
          <a:xfrm rot="19438225">
            <a:off x="1328924" y="2360865"/>
            <a:ext cx="182630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Y-95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5DE66C4-D3BB-8DE6-CBBB-5B0E2758B6F7}"/>
              </a:ext>
            </a:extLst>
          </p:cNvPr>
          <p:cNvSpPr txBox="1"/>
          <p:nvPr/>
        </p:nvSpPr>
        <p:spPr>
          <a:xfrm rot="19293923">
            <a:off x="1105772" y="2712714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C0F283D-929B-BAF5-8911-910CE0496E26}"/>
              </a:ext>
            </a:extLst>
          </p:cNvPr>
          <p:cNvSpPr txBox="1"/>
          <p:nvPr/>
        </p:nvSpPr>
        <p:spPr>
          <a:xfrm rot="19358509">
            <a:off x="1749915" y="2511916"/>
            <a:ext cx="123361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GFP966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ABD37419-F9FA-1973-E5EA-5BAEF4F2EC8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47" t="58295" r="25050" b="22520"/>
          <a:stretch/>
        </p:blipFill>
        <p:spPr bwMode="auto">
          <a:xfrm>
            <a:off x="616909" y="4307589"/>
            <a:ext cx="2472269" cy="906562"/>
          </a:xfrm>
          <a:prstGeom prst="rect">
            <a:avLst/>
          </a:prstGeom>
          <a:noFill/>
          <a:ln>
            <a:noFill/>
          </a:ln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12F37A23-1602-0368-5529-FD279475D1CD}"/>
              </a:ext>
            </a:extLst>
          </p:cNvPr>
          <p:cNvSpPr/>
          <p:nvPr/>
        </p:nvSpPr>
        <p:spPr>
          <a:xfrm>
            <a:off x="692911" y="4452558"/>
            <a:ext cx="2253974" cy="5813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135015C-9650-38EF-E5A7-FC44AC840392}"/>
              </a:ext>
            </a:extLst>
          </p:cNvPr>
          <p:cNvSpPr txBox="1"/>
          <p:nvPr/>
        </p:nvSpPr>
        <p:spPr>
          <a:xfrm rot="19293923">
            <a:off x="832827" y="3989009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9783E729-373E-C7AF-F72C-6B42051E1892}"/>
              </a:ext>
            </a:extLst>
          </p:cNvPr>
          <p:cNvSpPr txBox="1"/>
          <p:nvPr/>
        </p:nvSpPr>
        <p:spPr>
          <a:xfrm rot="19438225">
            <a:off x="2511779" y="3675016"/>
            <a:ext cx="149475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Ricolinost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5E11A4C-CDD6-BA96-9096-3E0C2A1D7665}"/>
              </a:ext>
            </a:extLst>
          </p:cNvPr>
          <p:cNvSpPr txBox="1"/>
          <p:nvPr/>
        </p:nvSpPr>
        <p:spPr>
          <a:xfrm rot="19438225">
            <a:off x="2097798" y="3429335"/>
            <a:ext cx="23653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MK-2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820B191D-E3C2-6362-A744-2F1F0D808B09}"/>
              </a:ext>
            </a:extLst>
          </p:cNvPr>
          <p:cNvSpPr txBox="1"/>
          <p:nvPr/>
        </p:nvSpPr>
        <p:spPr>
          <a:xfrm rot="19438225">
            <a:off x="1464255" y="3622336"/>
            <a:ext cx="182630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Y-95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85506F59-1E7E-6E5B-DDF0-0060B1C67FDA}"/>
              </a:ext>
            </a:extLst>
          </p:cNvPr>
          <p:cNvSpPr txBox="1"/>
          <p:nvPr/>
        </p:nvSpPr>
        <p:spPr>
          <a:xfrm rot="19293923">
            <a:off x="1252268" y="3973313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F7E5608-82D8-EF78-4D38-BB4EBEEA1AB3}"/>
              </a:ext>
            </a:extLst>
          </p:cNvPr>
          <p:cNvSpPr txBox="1"/>
          <p:nvPr/>
        </p:nvSpPr>
        <p:spPr>
          <a:xfrm rot="19358509">
            <a:off x="1896411" y="3772515"/>
            <a:ext cx="123361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GFP966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ED5F30F3-B5BF-B305-2F76-01EBA01FAEB3}"/>
              </a:ext>
            </a:extLst>
          </p:cNvPr>
          <p:cNvSpPr txBox="1"/>
          <p:nvPr/>
        </p:nvSpPr>
        <p:spPr>
          <a:xfrm>
            <a:off x="321722" y="466269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F1A71B10-D5F0-5DE5-1AE9-1AAB87BE9D3C}"/>
              </a:ext>
            </a:extLst>
          </p:cNvPr>
          <p:cNvSpPr txBox="1"/>
          <p:nvPr/>
        </p:nvSpPr>
        <p:spPr>
          <a:xfrm>
            <a:off x="243638" y="271433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3233EB6C-091C-D4D1-B924-9BF88159D707}"/>
              </a:ext>
            </a:extLst>
          </p:cNvPr>
          <p:cNvSpPr txBox="1"/>
          <p:nvPr/>
        </p:nvSpPr>
        <p:spPr>
          <a:xfrm>
            <a:off x="299294" y="402739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9" name="图片 58">
            <a:extLst>
              <a:ext uri="{FF2B5EF4-FFF2-40B4-BE49-F238E27FC236}">
                <a16:creationId xmlns:a16="http://schemas.microsoft.com/office/drawing/2014/main" id="{2EA612FD-8BB3-388C-E414-4D7DC71EF20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44" t="50000" r="19463" b="19826"/>
          <a:stretch/>
        </p:blipFill>
        <p:spPr bwMode="auto">
          <a:xfrm>
            <a:off x="605748" y="5806504"/>
            <a:ext cx="2564034" cy="1225086"/>
          </a:xfrm>
          <a:prstGeom prst="rect">
            <a:avLst/>
          </a:prstGeom>
          <a:noFill/>
          <a:ln>
            <a:noFill/>
          </a:ln>
        </p:spPr>
      </p:pic>
      <p:sp>
        <p:nvSpPr>
          <p:cNvPr id="60" name="矩形 59">
            <a:extLst>
              <a:ext uri="{FF2B5EF4-FFF2-40B4-BE49-F238E27FC236}">
                <a16:creationId xmlns:a16="http://schemas.microsoft.com/office/drawing/2014/main" id="{5D1120E5-E572-9545-8CCF-C651E673E9FE}"/>
              </a:ext>
            </a:extLst>
          </p:cNvPr>
          <p:cNvSpPr/>
          <p:nvPr/>
        </p:nvSpPr>
        <p:spPr>
          <a:xfrm>
            <a:off x="715053" y="5932022"/>
            <a:ext cx="2394625" cy="10422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E9840463-4061-3AB4-96F2-611AC9BFBE56}"/>
              </a:ext>
            </a:extLst>
          </p:cNvPr>
          <p:cNvSpPr txBox="1"/>
          <p:nvPr/>
        </p:nvSpPr>
        <p:spPr>
          <a:xfrm>
            <a:off x="375756" y="638142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4AC4D94F-BC4D-FDD1-D63C-C26F7C4E49FC}"/>
              </a:ext>
            </a:extLst>
          </p:cNvPr>
          <p:cNvSpPr txBox="1"/>
          <p:nvPr/>
        </p:nvSpPr>
        <p:spPr>
          <a:xfrm>
            <a:off x="265781" y="555402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2D7356E1-CE5E-30E3-94FB-E28BA2DA573F}"/>
              </a:ext>
            </a:extLst>
          </p:cNvPr>
          <p:cNvSpPr txBox="1"/>
          <p:nvPr/>
        </p:nvSpPr>
        <p:spPr>
          <a:xfrm rot="19293923">
            <a:off x="1038639" y="5506957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B1B527B6-4073-8157-69FF-C238638F50E2}"/>
              </a:ext>
            </a:extLst>
          </p:cNvPr>
          <p:cNvSpPr txBox="1"/>
          <p:nvPr/>
        </p:nvSpPr>
        <p:spPr>
          <a:xfrm rot="19438225">
            <a:off x="2706878" y="5181507"/>
            <a:ext cx="149475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Ricolinost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376FDD81-A358-1465-53C0-3A1F28A26BDC}"/>
              </a:ext>
            </a:extLst>
          </p:cNvPr>
          <p:cNvSpPr txBox="1"/>
          <p:nvPr/>
        </p:nvSpPr>
        <p:spPr>
          <a:xfrm rot="19438225">
            <a:off x="2325964" y="4938772"/>
            <a:ext cx="23653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MK-2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8A43A382-A7CA-876F-4ED7-C1E56B050CF9}"/>
              </a:ext>
            </a:extLst>
          </p:cNvPr>
          <p:cNvSpPr txBox="1"/>
          <p:nvPr/>
        </p:nvSpPr>
        <p:spPr>
          <a:xfrm rot="19438225">
            <a:off x="1673692" y="5099328"/>
            <a:ext cx="182630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Y-95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96A4F8AF-6767-2B92-3ADE-0CEADE5016AD}"/>
              </a:ext>
            </a:extLst>
          </p:cNvPr>
          <p:cNvSpPr txBox="1"/>
          <p:nvPr/>
        </p:nvSpPr>
        <p:spPr>
          <a:xfrm rot="19293923">
            <a:off x="1458080" y="5491261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B754E0BD-66E8-DB71-DB66-4E79D18D1EF8}"/>
              </a:ext>
            </a:extLst>
          </p:cNvPr>
          <p:cNvSpPr txBox="1"/>
          <p:nvPr/>
        </p:nvSpPr>
        <p:spPr>
          <a:xfrm rot="19358509">
            <a:off x="2102223" y="5290463"/>
            <a:ext cx="123361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GFP966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图片 68">
            <a:extLst>
              <a:ext uri="{FF2B5EF4-FFF2-40B4-BE49-F238E27FC236}">
                <a16:creationId xmlns:a16="http://schemas.microsoft.com/office/drawing/2014/main" id="{1E9C6A89-1722-B351-3E7D-14F20116D6C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70" t="40730" r="31466" b="38652"/>
          <a:stretch/>
        </p:blipFill>
        <p:spPr bwMode="auto">
          <a:xfrm>
            <a:off x="534097" y="7997572"/>
            <a:ext cx="2963007" cy="1157745"/>
          </a:xfrm>
          <a:prstGeom prst="rect">
            <a:avLst/>
          </a:prstGeom>
          <a:noFill/>
          <a:ln>
            <a:noFill/>
          </a:ln>
        </p:spPr>
      </p:pic>
      <p:sp>
        <p:nvSpPr>
          <p:cNvPr id="70" name="矩形 69">
            <a:extLst>
              <a:ext uri="{FF2B5EF4-FFF2-40B4-BE49-F238E27FC236}">
                <a16:creationId xmlns:a16="http://schemas.microsoft.com/office/drawing/2014/main" id="{7F26FFF9-97C7-F2BB-F371-25F1449B05A5}"/>
              </a:ext>
            </a:extLst>
          </p:cNvPr>
          <p:cNvSpPr/>
          <p:nvPr/>
        </p:nvSpPr>
        <p:spPr>
          <a:xfrm>
            <a:off x="537802" y="8055321"/>
            <a:ext cx="2959302" cy="10031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EFFAD48A-A302-FA91-66E3-257B2382E499}"/>
              </a:ext>
            </a:extLst>
          </p:cNvPr>
          <p:cNvSpPr txBox="1"/>
          <p:nvPr/>
        </p:nvSpPr>
        <p:spPr>
          <a:xfrm>
            <a:off x="199868" y="837073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0EAA791D-9F7E-0F3A-3CC7-4AFB277C48DA}"/>
              </a:ext>
            </a:extLst>
          </p:cNvPr>
          <p:cNvSpPr txBox="1"/>
          <p:nvPr/>
        </p:nvSpPr>
        <p:spPr>
          <a:xfrm>
            <a:off x="134344" y="7725619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96DD3D95-E9F9-61A2-9CB6-2EBE27B2B10C}"/>
              </a:ext>
            </a:extLst>
          </p:cNvPr>
          <p:cNvSpPr txBox="1"/>
          <p:nvPr/>
        </p:nvSpPr>
        <p:spPr>
          <a:xfrm>
            <a:off x="3562180" y="8326084"/>
            <a:ext cx="1512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WCL: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16FA7155-9886-7E90-90B6-7CD82D35EE39}"/>
              </a:ext>
            </a:extLst>
          </p:cNvPr>
          <p:cNvSpPr txBox="1"/>
          <p:nvPr/>
        </p:nvSpPr>
        <p:spPr>
          <a:xfrm rot="19293923">
            <a:off x="815048" y="7721137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898AE1D8-A8A4-F42D-4A3B-A4EB846F729F}"/>
              </a:ext>
            </a:extLst>
          </p:cNvPr>
          <p:cNvSpPr txBox="1"/>
          <p:nvPr/>
        </p:nvSpPr>
        <p:spPr>
          <a:xfrm rot="19438225">
            <a:off x="2768466" y="7406246"/>
            <a:ext cx="149475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Ricolinost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9842C6F9-25E1-9C6B-5FC6-60730C431487}"/>
              </a:ext>
            </a:extLst>
          </p:cNvPr>
          <p:cNvSpPr txBox="1"/>
          <p:nvPr/>
        </p:nvSpPr>
        <p:spPr>
          <a:xfrm rot="19438225">
            <a:off x="2232649" y="7145573"/>
            <a:ext cx="236531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MK-2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80536104-54E9-F6A5-86C2-2C14D452C1B2}"/>
              </a:ext>
            </a:extLst>
          </p:cNvPr>
          <p:cNvSpPr txBox="1"/>
          <p:nvPr/>
        </p:nvSpPr>
        <p:spPr>
          <a:xfrm rot="19438225">
            <a:off x="1450101" y="7313508"/>
            <a:ext cx="182630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Y-95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A41FEFDD-CA3A-7424-75B0-A36AF0023932}"/>
              </a:ext>
            </a:extLst>
          </p:cNvPr>
          <p:cNvSpPr txBox="1"/>
          <p:nvPr/>
        </p:nvSpPr>
        <p:spPr>
          <a:xfrm rot="19293923">
            <a:off x="1234489" y="7705441"/>
            <a:ext cx="5967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91C3D2D2-8ABC-7AB4-2482-057BE722F46F}"/>
              </a:ext>
            </a:extLst>
          </p:cNvPr>
          <p:cNvSpPr txBox="1"/>
          <p:nvPr/>
        </p:nvSpPr>
        <p:spPr>
          <a:xfrm rot="19358509">
            <a:off x="1878632" y="7504643"/>
            <a:ext cx="123361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GFP966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E85806F5-CFD2-6D7F-420A-B855A93EDFA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4344" y="381693"/>
            <a:ext cx="2881071" cy="2192425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33242B1D-8EAA-7062-28A8-48734DC565A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1836" y="3122889"/>
            <a:ext cx="2413579" cy="452546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5375BF0F-9A66-F03B-343B-656A6BA679A0}"/>
              </a:ext>
            </a:extLst>
          </p:cNvPr>
          <p:cNvSpPr/>
          <p:nvPr/>
        </p:nvSpPr>
        <p:spPr>
          <a:xfrm>
            <a:off x="706364" y="3090821"/>
            <a:ext cx="2261992" cy="5775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E27C21F8-D8AB-6447-6A38-633637A03BF6}"/>
              </a:ext>
            </a:extLst>
          </p:cNvPr>
          <p:cNvSpPr/>
          <p:nvPr/>
        </p:nvSpPr>
        <p:spPr>
          <a:xfrm>
            <a:off x="756525" y="3240109"/>
            <a:ext cx="2191249" cy="2102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01</TotalTime>
  <Words>67</Words>
  <Application>Microsoft Office PowerPoint</Application>
  <PresentationFormat>A4 纸张(210x297 毫米)</PresentationFormat>
  <Paragraphs>4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9</cp:revision>
  <dcterms:created xsi:type="dcterms:W3CDTF">2024-07-31T07:53:06Z</dcterms:created>
  <dcterms:modified xsi:type="dcterms:W3CDTF">2024-12-10T07:25:47Z</dcterms:modified>
</cp:coreProperties>
</file>